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0719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9157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1408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8752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895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19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16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8700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834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8988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89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431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E7E04366-529B-4E9B-9D4C-60EF73B7B31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4758" y="397412"/>
            <a:ext cx="2716836" cy="17457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544DE0CD-753A-4937-A56E-C4864E6A506D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303" y="426810"/>
            <a:ext cx="2704141" cy="174576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33C6989-84A1-4FA1-93D6-FEED54BDD078}"/>
              </a:ext>
            </a:extLst>
          </p:cNvPr>
          <p:cNvSpPr txBox="1"/>
          <p:nvPr/>
        </p:nvSpPr>
        <p:spPr>
          <a:xfrm>
            <a:off x="1327467" y="149811"/>
            <a:ext cx="1275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a. The first model</a:t>
            </a:r>
            <a:endParaRPr lang="ko-KR" alt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B977BEE-4B8C-4C18-8B09-E900F69FD865}"/>
              </a:ext>
            </a:extLst>
          </p:cNvPr>
          <p:cNvSpPr txBox="1"/>
          <p:nvPr/>
        </p:nvSpPr>
        <p:spPr>
          <a:xfrm>
            <a:off x="1333342" y="2400977"/>
            <a:ext cx="148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b. The second model</a:t>
            </a:r>
            <a:endParaRPr lang="ko-KR" alt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CCDA95-2F0C-4B9F-B6CB-C9C877AEAEF6}"/>
              </a:ext>
            </a:extLst>
          </p:cNvPr>
          <p:cNvSpPr txBox="1"/>
          <p:nvPr/>
        </p:nvSpPr>
        <p:spPr>
          <a:xfrm>
            <a:off x="1334758" y="4591183"/>
            <a:ext cx="13222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c. The third model</a:t>
            </a:r>
            <a:endParaRPr lang="ko-KR" altLang="en-US" sz="1200" dirty="0"/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44EF03AE-BE37-40FD-A6F9-DD465C340322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"/>
          <a:stretch/>
        </p:blipFill>
        <p:spPr bwMode="auto">
          <a:xfrm>
            <a:off x="1334758" y="2652577"/>
            <a:ext cx="2709544" cy="174576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CA9EE1E2-02E1-4C36-B8E8-1978B704378E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6303" y="2639787"/>
            <a:ext cx="2704142" cy="1745761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123BB050-537A-4B65-AAB3-822ED715C12C}"/>
              </a:ext>
            </a:extLst>
          </p:cNvPr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758" y="4836153"/>
            <a:ext cx="2709544" cy="1745761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B97CF987-97D7-41A3-A88A-1355C5AF249F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898" y="4859657"/>
            <a:ext cx="2704141" cy="169869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9470B0B-4F6F-49DB-8C0B-36A2A218F475}"/>
              </a:ext>
            </a:extLst>
          </p:cNvPr>
          <p:cNvSpPr txBox="1"/>
          <p:nvPr/>
        </p:nvSpPr>
        <p:spPr>
          <a:xfrm>
            <a:off x="3698907" y="2147813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01BAFC9-7DDB-47B2-B89D-B00494B59333}"/>
              </a:ext>
            </a:extLst>
          </p:cNvPr>
          <p:cNvSpPr txBox="1"/>
          <p:nvPr/>
        </p:nvSpPr>
        <p:spPr>
          <a:xfrm>
            <a:off x="3730215" y="4398979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65EAC2B-6069-4A75-970D-C8C9F0686E8C}"/>
              </a:ext>
            </a:extLst>
          </p:cNvPr>
          <p:cNvSpPr txBox="1"/>
          <p:nvPr/>
        </p:nvSpPr>
        <p:spPr>
          <a:xfrm>
            <a:off x="3730215" y="6558356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79314FE-A3DB-47E1-9AB5-ADDB42F72D75}"/>
              </a:ext>
            </a:extLst>
          </p:cNvPr>
          <p:cNvSpPr txBox="1"/>
          <p:nvPr/>
        </p:nvSpPr>
        <p:spPr>
          <a:xfrm>
            <a:off x="6660318" y="2147813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A26383-1C86-4521-9486-EAC6F566BA5F}"/>
              </a:ext>
            </a:extLst>
          </p:cNvPr>
          <p:cNvSpPr txBox="1"/>
          <p:nvPr/>
        </p:nvSpPr>
        <p:spPr>
          <a:xfrm>
            <a:off x="6660317" y="4344962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98C61AD-BB2C-4EA9-A3CA-FEF0D2A45088}"/>
              </a:ext>
            </a:extLst>
          </p:cNvPr>
          <p:cNvSpPr txBox="1"/>
          <p:nvPr/>
        </p:nvSpPr>
        <p:spPr>
          <a:xfrm>
            <a:off x="6660317" y="6558356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8D53B57-9035-4903-A947-ABE2D1D62A95}"/>
              </a:ext>
            </a:extLst>
          </p:cNvPr>
          <p:cNvSpPr txBox="1"/>
          <p:nvPr/>
        </p:nvSpPr>
        <p:spPr>
          <a:xfrm>
            <a:off x="785447" y="392772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1DD6390-6FC8-43A6-9A13-5D83F6965C03}"/>
              </a:ext>
            </a:extLst>
          </p:cNvPr>
          <p:cNvSpPr txBox="1"/>
          <p:nvPr/>
        </p:nvSpPr>
        <p:spPr>
          <a:xfrm>
            <a:off x="785447" y="2651288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BEC977-89BE-4F61-B348-733685BA5919}"/>
              </a:ext>
            </a:extLst>
          </p:cNvPr>
          <p:cNvSpPr txBox="1"/>
          <p:nvPr/>
        </p:nvSpPr>
        <p:spPr>
          <a:xfrm>
            <a:off x="785447" y="4836153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1FF1BE1-24F9-4D95-9BC7-7037743D2CA6}"/>
              </a:ext>
            </a:extLst>
          </p:cNvPr>
          <p:cNvSpPr txBox="1"/>
          <p:nvPr/>
        </p:nvSpPr>
        <p:spPr>
          <a:xfrm>
            <a:off x="4225880" y="426810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96EEBF-73D4-4B73-A3FB-3B1477424C32}"/>
              </a:ext>
            </a:extLst>
          </p:cNvPr>
          <p:cNvSpPr txBox="1"/>
          <p:nvPr/>
        </p:nvSpPr>
        <p:spPr>
          <a:xfrm>
            <a:off x="4225880" y="2651288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A91722-9F31-4522-958D-23F63FA2954A}"/>
              </a:ext>
            </a:extLst>
          </p:cNvPr>
          <p:cNvSpPr txBox="1"/>
          <p:nvPr/>
        </p:nvSpPr>
        <p:spPr>
          <a:xfrm>
            <a:off x="4225880" y="4836152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8385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30</Words>
  <Application>Microsoft Office PowerPoint</Application>
  <PresentationFormat>화면 슬라이드 쇼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보미</dc:creator>
  <cp:lastModifiedBy>박 보미</cp:lastModifiedBy>
  <cp:revision>5</cp:revision>
  <dcterms:created xsi:type="dcterms:W3CDTF">2019-09-22T14:41:33Z</dcterms:created>
  <dcterms:modified xsi:type="dcterms:W3CDTF">2019-09-25T06:34:35Z</dcterms:modified>
</cp:coreProperties>
</file>